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4608"/>
    <p:restoredTop sz="86369"/>
  </p:normalViewPr>
  <p:slideViewPr>
    <p:cSldViewPr snapToGrid="0" snapToObjects="1">
      <p:cViewPr varScale="1">
        <p:scale>
          <a:sx n="137" d="100"/>
          <a:sy n="137" d="100"/>
        </p:scale>
        <p:origin x="2360" y="19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6756926136999211"/>
          <c:y val="0.2036220960538735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49</c:f>
              <c:strCache>
                <c:ptCount val="1"/>
                <c:pt idx="0">
                  <c:v>Dalla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8:$J$78</c:f>
                <c:numCache>
                  <c:formatCode>General</c:formatCode>
                  <c:ptCount val="9"/>
                  <c:pt idx="0">
                    <c:v>8.2663464154601393E-3</c:v>
                  </c:pt>
                  <c:pt idx="1">
                    <c:v>1.3813974924518699E-2</c:v>
                  </c:pt>
                  <c:pt idx="2">
                    <c:v>3.3390919892375401E-2</c:v>
                  </c:pt>
                  <c:pt idx="3">
                    <c:v>1.62594222511065E-3</c:v>
                  </c:pt>
                  <c:pt idx="4">
                    <c:v>2.25948099801381E-3</c:v>
                  </c:pt>
                  <c:pt idx="5">
                    <c:v>1.1657203421778299E-2</c:v>
                  </c:pt>
                  <c:pt idx="6">
                    <c:v>1.3284520299894499E-2</c:v>
                  </c:pt>
                  <c:pt idx="7">
                    <c:v>1.22525206467706E-2</c:v>
                  </c:pt>
                  <c:pt idx="8">
                    <c:v>6.0420675113690599E-2</c:v>
                  </c:pt>
                </c:numCache>
              </c:numRef>
            </c:plus>
            <c:minus>
              <c:numRef>
                <c:f>'Sheet 1 - county estimates'!$B$78:$J$78</c:f>
                <c:numCache>
                  <c:formatCode>General</c:formatCode>
                  <c:ptCount val="9"/>
                  <c:pt idx="0">
                    <c:v>8.2663464154601393E-3</c:v>
                  </c:pt>
                  <c:pt idx="1">
                    <c:v>1.3813974924518699E-2</c:v>
                  </c:pt>
                  <c:pt idx="2">
                    <c:v>3.3390919892375401E-2</c:v>
                  </c:pt>
                  <c:pt idx="3">
                    <c:v>1.62594222511065E-3</c:v>
                  </c:pt>
                  <c:pt idx="4">
                    <c:v>2.25948099801381E-3</c:v>
                  </c:pt>
                  <c:pt idx="5">
                    <c:v>1.1657203421778299E-2</c:v>
                  </c:pt>
                  <c:pt idx="6">
                    <c:v>1.3284520299894499E-2</c:v>
                  </c:pt>
                  <c:pt idx="7">
                    <c:v>1.22525206467706E-2</c:v>
                  </c:pt>
                  <c:pt idx="8">
                    <c:v>6.04206751136905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48:$J$48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49:$J$49</c:f>
              <c:numCache>
                <c:formatCode>General</c:formatCode>
                <c:ptCount val="9"/>
                <c:pt idx="0">
                  <c:v>0.112961560481093</c:v>
                </c:pt>
                <c:pt idx="1">
                  <c:v>0.12969773507405299</c:v>
                </c:pt>
                <c:pt idx="2">
                  <c:v>0.19579413764352799</c:v>
                </c:pt>
                <c:pt idx="3">
                  <c:v>4.9943847526165798E-2</c:v>
                </c:pt>
                <c:pt idx="4">
                  <c:v>3.9502863782344598E-2</c:v>
                </c:pt>
                <c:pt idx="5">
                  <c:v>0.125807653787223</c:v>
                </c:pt>
                <c:pt idx="6">
                  <c:v>0.12632074088996001</c:v>
                </c:pt>
                <c:pt idx="7">
                  <c:v>0.148634929754245</c:v>
                </c:pt>
                <c:pt idx="8">
                  <c:v>0.288486770476885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A3-9647-9AD5-773DD590D4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6347306588459364"/>
          <c:y val="0.204792928057239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51</c:f>
              <c:strCache>
                <c:ptCount val="1"/>
                <c:pt idx="0">
                  <c:v>Randal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9:$J$79</c:f>
                <c:numCache>
                  <c:formatCode>General</c:formatCode>
                  <c:ptCount val="9"/>
                  <c:pt idx="0">
                    <c:v>9.2933680562339305E-3</c:v>
                  </c:pt>
                  <c:pt idx="1">
                    <c:v>1.1667823778419699E-2</c:v>
                  </c:pt>
                  <c:pt idx="2">
                    <c:v>4.2835404246678699E-2</c:v>
                  </c:pt>
                  <c:pt idx="3">
                    <c:v>9.7651597142086905E-4</c:v>
                  </c:pt>
                  <c:pt idx="4">
                    <c:v>1.07044501979766E-3</c:v>
                  </c:pt>
                  <c:pt idx="5">
                    <c:v>1.6005851582427202E-2</c:v>
                  </c:pt>
                  <c:pt idx="6">
                    <c:v>2.59615068727648E-2</c:v>
                  </c:pt>
                  <c:pt idx="7">
                    <c:v>2.5526953410313798E-2</c:v>
                  </c:pt>
                  <c:pt idx="8">
                    <c:v>9.6379716118569297E-2</c:v>
                  </c:pt>
                </c:numCache>
              </c:numRef>
            </c:plus>
            <c:minus>
              <c:numRef>
                <c:f>'Sheet 1 - county estimates'!$B$79:$J$79</c:f>
                <c:numCache>
                  <c:formatCode>General</c:formatCode>
                  <c:ptCount val="9"/>
                  <c:pt idx="0">
                    <c:v>9.2933680562339305E-3</c:v>
                  </c:pt>
                  <c:pt idx="1">
                    <c:v>1.1667823778419699E-2</c:v>
                  </c:pt>
                  <c:pt idx="2">
                    <c:v>4.2835404246678699E-2</c:v>
                  </c:pt>
                  <c:pt idx="3">
                    <c:v>9.7651597142086905E-4</c:v>
                  </c:pt>
                  <c:pt idx="4">
                    <c:v>1.07044501979766E-3</c:v>
                  </c:pt>
                  <c:pt idx="5">
                    <c:v>1.6005851582427202E-2</c:v>
                  </c:pt>
                  <c:pt idx="6">
                    <c:v>2.59615068727648E-2</c:v>
                  </c:pt>
                  <c:pt idx="7">
                    <c:v>2.5526953410313798E-2</c:v>
                  </c:pt>
                  <c:pt idx="8">
                    <c:v>9.63797161185692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50:$J$50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51:$J$51</c:f>
              <c:numCache>
                <c:formatCode>General</c:formatCode>
                <c:ptCount val="9"/>
                <c:pt idx="0">
                  <c:v>9.9566050549079202E-2</c:v>
                </c:pt>
                <c:pt idx="1">
                  <c:v>9.1594977623582804E-2</c:v>
                </c:pt>
                <c:pt idx="2">
                  <c:v>0.16932511552106999</c:v>
                </c:pt>
                <c:pt idx="3">
                  <c:v>3.14320517012577E-2</c:v>
                </c:pt>
                <c:pt idx="4">
                  <c:v>2.1513404784998E-2</c:v>
                </c:pt>
                <c:pt idx="5">
                  <c:v>0.116367454922577</c:v>
                </c:pt>
                <c:pt idx="6">
                  <c:v>0.155565554028542</c:v>
                </c:pt>
                <c:pt idx="7">
                  <c:v>0.17106958720510701</c:v>
                </c:pt>
                <c:pt idx="8">
                  <c:v>0.31000142050469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36-3E41-8AE6-F2F92D277C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958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52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270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25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978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38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10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304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48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425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508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633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E8D3ABB7-A2FC-1C47-A6B1-6652B7D3C012}"/>
              </a:ext>
            </a:extLst>
          </p:cNvPr>
          <p:cNvSpPr/>
          <p:nvPr/>
        </p:nvSpPr>
        <p:spPr>
          <a:xfrm>
            <a:off x="2146884" y="5642459"/>
            <a:ext cx="529160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228600" algn="l"/>
              </a:tabLst>
            </a:pP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5 Figure. Probability of </a:t>
            </a:r>
            <a:r>
              <a:rPr lang="en-US" sz="1200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. </a:t>
            </a:r>
            <a:r>
              <a:rPr lang="en-US" sz="1200" i="1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osichella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iotype 1 occurrence (mean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± SE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at locations in Dallam (A) and Randall (B) county Texas in 2014, 2015 and 2016.</a:t>
            </a:r>
            <a:endParaRPr lang="en-US" sz="14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 Box 18">
            <a:extLst>
              <a:ext uri="{FF2B5EF4-FFF2-40B4-BE49-F238E27FC236}">
                <a16:creationId xmlns:a16="http://schemas.microsoft.com/office/drawing/2014/main" id="{B739D434-6B5C-AE48-8652-C5EA13703E49}"/>
              </a:ext>
            </a:extLst>
          </p:cNvPr>
          <p:cNvSpPr txBox="1"/>
          <p:nvPr/>
        </p:nvSpPr>
        <p:spPr>
          <a:xfrm rot="10800000">
            <a:off x="2394810" y="984708"/>
            <a:ext cx="397669" cy="4079819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eaVert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robability of </a:t>
            </a:r>
            <a:r>
              <a:rPr lang="en-US" sz="1200" b="1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. </a:t>
            </a:r>
            <a:r>
              <a:rPr lang="en-US" sz="1200" b="1" i="1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oschiella</a:t>
            </a:r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iotype 1 occurrence (mean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± </a:t>
            </a:r>
            <a:r>
              <a:rPr lang="en-US" sz="12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E)</a:t>
            </a:r>
            <a:endParaRPr lang="en-US" sz="12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 Box 16">
            <a:extLst>
              <a:ext uri="{FF2B5EF4-FFF2-40B4-BE49-F238E27FC236}">
                <a16:creationId xmlns:a16="http://schemas.microsoft.com/office/drawing/2014/main" id="{309FB0DE-D32E-7F45-9519-7707D20C9089}"/>
              </a:ext>
            </a:extLst>
          </p:cNvPr>
          <p:cNvSpPr txBox="1"/>
          <p:nvPr/>
        </p:nvSpPr>
        <p:spPr>
          <a:xfrm>
            <a:off x="4145680" y="5236923"/>
            <a:ext cx="2067801" cy="267176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4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ample Month and Year</a:t>
            </a:r>
            <a:endParaRPr lang="en-US" sz="1400" dirty="0"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F972842-3B1D-4224-B7F7-88BB0FDE0BA7}"/>
              </a:ext>
            </a:extLst>
          </p:cNvPr>
          <p:cNvGrpSpPr/>
          <p:nvPr/>
        </p:nvGrpSpPr>
        <p:grpSpPr>
          <a:xfrm>
            <a:off x="2792480" y="984708"/>
            <a:ext cx="4094418" cy="4252215"/>
            <a:chOff x="-7264618" y="580168"/>
            <a:chExt cx="6746149" cy="6100594"/>
          </a:xfrm>
        </p:grpSpPr>
        <p:graphicFrame>
          <p:nvGraphicFramePr>
            <p:cNvPr id="28" name="Chart 27">
              <a:extLst>
                <a:ext uri="{FF2B5EF4-FFF2-40B4-BE49-F238E27FC236}">
                  <a16:creationId xmlns:a16="http://schemas.microsoft.com/office/drawing/2014/main" id="{309BD8AC-FD1B-4410-BC3B-42358854141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498031239"/>
                </p:ext>
              </p:extLst>
            </p:nvPr>
          </p:nvGraphicFramePr>
          <p:xfrm>
            <a:off x="-7264618" y="580168"/>
            <a:ext cx="6746149" cy="30550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9" name="Chart 28">
              <a:extLst>
                <a:ext uri="{FF2B5EF4-FFF2-40B4-BE49-F238E27FC236}">
                  <a16:creationId xmlns:a16="http://schemas.microsoft.com/office/drawing/2014/main" id="{FE8B8EC4-D091-46CF-921D-C2C08443312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10583069"/>
                </p:ext>
              </p:extLst>
            </p:nvPr>
          </p:nvGraphicFramePr>
          <p:xfrm>
            <a:off x="-7264618" y="3625700"/>
            <a:ext cx="6746148" cy="30550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E17810CD-ED43-0C49-B2F3-E1E8B1C7AE27}"/>
              </a:ext>
            </a:extLst>
          </p:cNvPr>
          <p:cNvSpPr>
            <a:spLocks noChangeAspect="1"/>
          </p:cNvSpPr>
          <p:nvPr/>
        </p:nvSpPr>
        <p:spPr>
          <a:xfrm>
            <a:off x="3187259" y="1193993"/>
            <a:ext cx="300044" cy="260907"/>
          </a:xfrm>
          <a:prstGeom prst="rect">
            <a:avLst/>
          </a:prstGeom>
          <a:noFill/>
          <a:ln w="2667">
            <a:noFill/>
          </a:ln>
        </p:spPr>
        <p:txBody>
          <a:bodyPr wrap="none">
            <a:no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PMingLiU" panose="02020500000000000000" pitchFamily="18" charset="-120"/>
                <a:cs typeface="Calibri" panose="020F0502020204030204" pitchFamily="34" charset="0"/>
              </a:rPr>
              <a:t>A</a:t>
            </a:r>
            <a:endParaRPr lang="en-US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085D1A7-D7FF-ED48-9232-DA91D7839AF4}"/>
              </a:ext>
            </a:extLst>
          </p:cNvPr>
          <p:cNvSpPr>
            <a:spLocks noChangeAspect="1"/>
          </p:cNvSpPr>
          <p:nvPr/>
        </p:nvSpPr>
        <p:spPr>
          <a:xfrm flipH="1">
            <a:off x="3187259" y="3338567"/>
            <a:ext cx="343451" cy="260906"/>
          </a:xfrm>
          <a:prstGeom prst="rect">
            <a:avLst/>
          </a:prstGeom>
          <a:noFill/>
          <a:ln w="3175">
            <a:noFill/>
          </a:ln>
        </p:spPr>
        <p:txBody>
          <a:bodyPr wrap="none">
            <a:no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PMingLiU" panose="02020500000000000000" pitchFamily="18" charset="-120"/>
                <a:cs typeface="Calibri" panose="020F0502020204030204" pitchFamily="34" charset="0"/>
              </a:rPr>
              <a:t>B</a:t>
            </a:r>
            <a:endParaRPr lang="en-US" sz="16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9928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</TotalTime>
  <Words>58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 Smith</dc:creator>
  <cp:lastModifiedBy>Microsoft Office User</cp:lastModifiedBy>
  <cp:revision>13</cp:revision>
  <dcterms:created xsi:type="dcterms:W3CDTF">2019-11-04T20:35:29Z</dcterms:created>
  <dcterms:modified xsi:type="dcterms:W3CDTF">2020-04-10T15:48:20Z</dcterms:modified>
</cp:coreProperties>
</file>